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458851" y="11189089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figure supplement 4—source data 1. PowerPoint file containing original western blots for Figure 4—figure supplement 4a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3EA3D443-71C3-4CCB-BE80-45416DCCD09B}"/>
              </a:ext>
            </a:extLst>
          </p:cNvPr>
          <p:cNvGrpSpPr/>
          <p:nvPr/>
        </p:nvGrpSpPr>
        <p:grpSpPr>
          <a:xfrm>
            <a:off x="844777" y="4020965"/>
            <a:ext cx="17155886" cy="5985919"/>
            <a:chOff x="0" y="-442178"/>
            <a:chExt cx="20946915" cy="8233673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F6DCBC8E-3324-46E6-A3C6-695408E41E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261937" y="605853"/>
              <a:ext cx="8582827" cy="6063534"/>
            </a:xfrm>
            <a:prstGeom prst="rect">
              <a:avLst/>
            </a:prstGeom>
          </p:spPr>
        </p:pic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F8D50927-6F74-4910-89F7-D5222D128688}"/>
                </a:ext>
              </a:extLst>
            </p:cNvPr>
            <p:cNvGrpSpPr/>
            <p:nvPr/>
          </p:nvGrpSpPr>
          <p:grpSpPr>
            <a:xfrm>
              <a:off x="0" y="708009"/>
              <a:ext cx="9701593" cy="6479119"/>
              <a:chOff x="19652848" y="11798239"/>
              <a:chExt cx="7638797" cy="6479119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D83D3329-7DC3-4EEF-AC8F-6597EA4F8E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445893" y="11850132"/>
                <a:ext cx="6845751" cy="6427226"/>
              </a:xfrm>
              <a:prstGeom prst="rect">
                <a:avLst/>
              </a:prstGeom>
            </p:spPr>
          </p:pic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F0A8B7DC-66C6-4575-B5D1-F96D182B4F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9652848" y="11798239"/>
                <a:ext cx="846218" cy="6427226"/>
              </a:xfrm>
              <a:prstGeom prst="rect">
                <a:avLst/>
              </a:prstGeom>
            </p:spPr>
          </p:pic>
          <p:sp>
            <p:nvSpPr>
              <p:cNvPr id="7" name="矩形 6">
                <a:extLst>
                  <a:ext uri="{FF2B5EF4-FFF2-40B4-BE49-F238E27FC236}">
                    <a16:creationId xmlns:a16="http://schemas.microsoft.com/office/drawing/2014/main" id="{E1AE4AD5-10D1-4178-BA30-D4C74D431CAA}"/>
                  </a:ext>
                </a:extLst>
              </p:cNvPr>
              <p:cNvSpPr/>
              <p:nvPr/>
            </p:nvSpPr>
            <p:spPr>
              <a:xfrm>
                <a:off x="20533737" y="12776200"/>
                <a:ext cx="6757908" cy="2766546"/>
              </a:xfrm>
              <a:prstGeom prst="rect">
                <a:avLst/>
              </a:prstGeom>
              <a:noFill/>
              <a:ln w="730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/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6289672-C7D0-4EC2-9B05-6E81697A0713}"/>
                </a:ext>
              </a:extLst>
            </p:cNvPr>
            <p:cNvSpPr txBox="1"/>
            <p:nvPr/>
          </p:nvSpPr>
          <p:spPr>
            <a:xfrm>
              <a:off x="2447677" y="-442178"/>
              <a:ext cx="1002890" cy="804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BB129F0-FD96-426B-A63B-8DDC9D25908D}"/>
                </a:ext>
              </a:extLst>
            </p:cNvPr>
            <p:cNvSpPr txBox="1"/>
            <p:nvPr/>
          </p:nvSpPr>
          <p:spPr>
            <a:xfrm>
              <a:off x="3755965" y="-386638"/>
              <a:ext cx="3529409" cy="804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RNAi-RLP#1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7619F68C-5A5E-4141-8B86-70AB83D1C060}"/>
                </a:ext>
              </a:extLst>
            </p:cNvPr>
            <p:cNvSpPr/>
            <p:nvPr/>
          </p:nvSpPr>
          <p:spPr>
            <a:xfrm flipV="1">
              <a:off x="1605998" y="393362"/>
              <a:ext cx="204247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537C9947-2950-438D-8588-23649CE487C1}"/>
                </a:ext>
              </a:extLst>
            </p:cNvPr>
            <p:cNvSpPr/>
            <p:nvPr/>
          </p:nvSpPr>
          <p:spPr>
            <a:xfrm flipV="1">
              <a:off x="4191219" y="430958"/>
              <a:ext cx="204247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A423EBF7-697B-4C69-87F9-A84DAB900535}"/>
                </a:ext>
              </a:extLst>
            </p:cNvPr>
            <p:cNvSpPr/>
            <p:nvPr/>
          </p:nvSpPr>
          <p:spPr>
            <a:xfrm flipV="1">
              <a:off x="7103177" y="430958"/>
              <a:ext cx="2042470" cy="52664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A0F17F7-47B9-4FF2-B454-5618EB1F18E8}"/>
                </a:ext>
              </a:extLst>
            </p:cNvPr>
            <p:cNvSpPr txBox="1"/>
            <p:nvPr/>
          </p:nvSpPr>
          <p:spPr>
            <a:xfrm>
              <a:off x="6960502" y="-381217"/>
              <a:ext cx="3529409" cy="804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RNAi-RLP#2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C5C72E0-D6BF-4BCE-AC23-0C19CDD4DF77}"/>
                </a:ext>
              </a:extLst>
            </p:cNvPr>
            <p:cNvSpPr txBox="1"/>
            <p:nvPr/>
          </p:nvSpPr>
          <p:spPr>
            <a:xfrm>
              <a:off x="12904681" y="-440386"/>
              <a:ext cx="1002890" cy="804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4BE0051-77A1-4A11-AC77-340CA5A6C58B}"/>
                </a:ext>
              </a:extLst>
            </p:cNvPr>
            <p:cNvSpPr txBox="1"/>
            <p:nvPr/>
          </p:nvSpPr>
          <p:spPr>
            <a:xfrm>
              <a:off x="14212969" y="-384845"/>
              <a:ext cx="3529409" cy="804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RNAi-RLP#1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CBAC18A9-2FE8-4A0F-8244-8A3743F7C2C9}"/>
                </a:ext>
              </a:extLst>
            </p:cNvPr>
            <p:cNvSpPr/>
            <p:nvPr/>
          </p:nvSpPr>
          <p:spPr>
            <a:xfrm flipV="1">
              <a:off x="12063002" y="395154"/>
              <a:ext cx="204247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00EAE146-947E-4572-9ED9-6F4BE6F1DE1D}"/>
                </a:ext>
              </a:extLst>
            </p:cNvPr>
            <p:cNvSpPr/>
            <p:nvPr/>
          </p:nvSpPr>
          <p:spPr>
            <a:xfrm flipV="1">
              <a:off x="14648223" y="432750"/>
              <a:ext cx="2042470" cy="45719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5360F53E-08ED-40F8-BA93-7BA77AB84DAE}"/>
                </a:ext>
              </a:extLst>
            </p:cNvPr>
            <p:cNvSpPr/>
            <p:nvPr/>
          </p:nvSpPr>
          <p:spPr>
            <a:xfrm flipV="1">
              <a:off x="17560181" y="439080"/>
              <a:ext cx="2042470" cy="46333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F5C1793F-C796-4D08-90D8-AAD2EA6AB591}"/>
                </a:ext>
              </a:extLst>
            </p:cNvPr>
            <p:cNvSpPr txBox="1"/>
            <p:nvPr/>
          </p:nvSpPr>
          <p:spPr>
            <a:xfrm>
              <a:off x="17417506" y="-379425"/>
              <a:ext cx="3529409" cy="8043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dirty="0">
                  <a:latin typeface="Arial" panose="020B0604020202020204" pitchFamily="34" charset="0"/>
                  <a:cs typeface="Arial" panose="020B0604020202020204" pitchFamily="34" charset="0"/>
                </a:rPr>
                <a:t>RNAi-RLP#2</a:t>
              </a:r>
              <a:endParaRPr lang="zh-CN" altLang="en-US" sz="3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3B8DAD6-DC4F-40B9-BA38-839BFC0FD87D}"/>
                </a:ext>
              </a:extLst>
            </p:cNvPr>
            <p:cNvSpPr txBox="1"/>
            <p:nvPr/>
          </p:nvSpPr>
          <p:spPr>
            <a:xfrm>
              <a:off x="3625375" y="6902462"/>
              <a:ext cx="2877671" cy="8890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α-</a:t>
              </a:r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NtRLP4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ECC5148-E514-4C0D-8C74-25E3AE4D3D31}"/>
                </a:ext>
              </a:extLst>
            </p:cNvPr>
            <p:cNvSpPr txBox="1"/>
            <p:nvPr/>
          </p:nvSpPr>
          <p:spPr>
            <a:xfrm>
              <a:off x="14803995" y="6902462"/>
              <a:ext cx="2877671" cy="8890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dirty="0">
                  <a:latin typeface="Arial" panose="020B0604020202020204" pitchFamily="34" charset="0"/>
                  <a:cs typeface="Arial" panose="020B0604020202020204" pitchFamily="34" charset="0"/>
                </a:rPr>
                <a:t>RbcL</a:t>
              </a:r>
              <a:endParaRPr lang="zh-CN" altLang="en-US" sz="3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530B878E-7F87-46B3-8BC0-1956E8736FC8}"/>
                </a:ext>
              </a:extLst>
            </p:cNvPr>
            <p:cNvSpPr txBox="1"/>
            <p:nvPr/>
          </p:nvSpPr>
          <p:spPr>
            <a:xfrm>
              <a:off x="1818038" y="1726644"/>
              <a:ext cx="17993032" cy="38101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tRLP4</a:t>
              </a:r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50</Words>
  <Application>Microsoft Office PowerPoint</Application>
  <PresentationFormat>自定义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08:24Z</dcterms:modified>
</cp:coreProperties>
</file>